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2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7" autoAdjust="0"/>
    <p:restoredTop sz="94660"/>
  </p:normalViewPr>
  <p:slideViewPr>
    <p:cSldViewPr snapToGrid="0">
      <p:cViewPr varScale="1">
        <p:scale>
          <a:sx n="74" d="100"/>
          <a:sy n="74" d="100"/>
        </p:scale>
        <p:origin x="-378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83BB4D07-EE58-4885-AEC5-36C4CF7CAB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ACA9E757-D4E3-411C-8B07-520BCD84F4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756928E9-BD6E-48FD-8B96-1D3F77A26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492E2113-C500-4057-8AB4-4155688C5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F62FDC8D-EEBF-40DF-93EC-4C318D385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2652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C8B8696-082A-4DF7-9A5B-EF02C6369B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9487737D-4CE3-4EB5-B0FB-9C7B8FE5D0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FBA1ECE7-7B1D-4858-AA6A-EF0A1F44A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292A888-7AA9-4785-8187-CBBBBAFB6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4A83DE10-81BC-49B4-8DC3-2CF046CC7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17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35506A93-E3F9-4EEC-BAEF-A6D8A1E613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40156370-0615-4CF2-A85D-5D30FCECC0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CAED0916-CBC1-4E38-B46E-4E2009D87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5BDC405C-A826-4A20-900D-C675C4507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E86481DF-B130-404E-886A-33B6AA0B0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622128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6/21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28422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730B95F3-5802-4951-B856-A9020CD467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9D678FB6-776E-4F9D-B299-B09E231830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55066558-0561-4F9D-B588-BD031AF45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2FB685D-34F6-4B22-9FFE-6A8976980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51459355-D050-483D-A182-F6199EBF3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4708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ABC57F09-AB86-443D-AA3F-F18825602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946A8F1D-D2EC-4E5D-8E36-A318954B2A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B1D609CC-DA6B-4C79-ACF9-0705562B9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D6577BB3-4655-4CE6-816E-C4A746667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C6BA6848-9970-43DC-A04A-6A765B0EC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907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E4723E3B-35FA-4445-90D8-B6F3F432D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BDE53869-C9B5-482D-A8E4-3C1BF684D0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761C9646-751C-4535-BE89-DC796D92CE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CEF791E7-80C2-479F-9B42-4C7970F29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AAE77D4B-4154-4226-A0EB-391C1883D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500364F7-BF6A-4AA3-8138-ABA95766D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0331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235CAEB-04A4-4C1E-9BE6-CF5CB39BBB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F5535E57-4A7C-479E-BC70-FB6ABF0C85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900257EF-FEA8-444E-A6FA-FBF3687209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18EB63CA-D7D1-4153-9F8B-D23ADD97F0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D708AF4B-D011-4C75-9F52-0CB1A942CA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23797A57-586B-485B-82EF-DD52FEFDD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9828FDFA-58A1-4A2A-9101-CDCB2627A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9B7584E1-84F7-40D1-A107-857CDEDF6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834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623AE106-5B20-4CF3-954E-EF8B7D8EE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AACF700C-BA71-4030-BE93-7D33C57B5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DDC47C81-B506-460F-ACD3-4DC1349AE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C79A53C8-C76A-4CAC-B3DC-2EFD8258F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284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DB5C3BF4-8608-4B08-8C3C-A7F89A515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49CA3500-89E2-4E79-9717-05E358EF2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14493A34-91B2-476B-8A74-308C04657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5794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B013055C-C570-4B17-8A91-67C676795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97C60848-5CCB-46D4-A6AE-A9711F2B38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46506870-9D49-40C4-8C84-68A7D5CB78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951CF148-F761-4BCC-9E84-91BB417FC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75FDFBC6-6B19-4DC3-AD9C-9C6D3B618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D02DF5D8-B57F-4419-B226-80C411BB3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094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F0ECFFC9-8BA4-4270-9974-34D4B3CF9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AA8D57F1-1A9D-4301-8ACF-282602FDDE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B2E09418-7F48-4EFE-AD0D-4D7115E152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5AB16B28-71D2-4309-A12E-A04F5E02C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823539C8-1368-4DAC-9500-CB1FB7F7C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8DD10D1E-070F-499F-BB95-2A4B15F39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091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529F6E2A-F3DE-4EA0-BDD6-99F6EC25D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135A5686-F68A-4FB2-B6B8-E28B1A69C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236DA87D-FCBC-4882-96C7-4D7717569F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594D0-837C-4DBE-89AB-D13A439C0988}" type="datetimeFigureOut">
              <a:rPr lang="ko-KR" altLang="en-US" smtClean="0"/>
              <a:t>2020-06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34282A3B-FE48-48C5-B442-8CFFF16294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DD67A0EE-39FE-45B5-9CF1-BB3FC911F9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9362C-50AC-4FD7-949C-9BE5315A80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7424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object 24"/>
          <p:cNvSpPr/>
          <p:nvPr/>
        </p:nvSpPr>
        <p:spPr>
          <a:xfrm>
            <a:off x="7388798" y="760721"/>
            <a:ext cx="1609041" cy="558991"/>
          </a:xfrm>
          <a:custGeom>
            <a:avLst/>
            <a:gdLst/>
            <a:ahLst/>
            <a:cxnLst/>
            <a:rect l="l" t="t" r="r" b="b"/>
            <a:pathLst>
              <a:path w="1579244" h="548639">
                <a:moveTo>
                  <a:pt x="0" y="0"/>
                </a:moveTo>
                <a:lnTo>
                  <a:pt x="1579244" y="0"/>
                </a:lnTo>
                <a:lnTo>
                  <a:pt x="1579244" y="548639"/>
                </a:lnTo>
                <a:lnTo>
                  <a:pt x="0" y="548639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>
            <a:noAutofit/>
          </a:bodyPr>
          <a:lstStyle/>
          <a:p>
            <a:endParaRPr sz="1834"/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xmlns="" id="{81F0DB28-F0B0-48C6-A851-979AE38DEE47}"/>
              </a:ext>
            </a:extLst>
          </p:cNvPr>
          <p:cNvGrpSpPr/>
          <p:nvPr/>
        </p:nvGrpSpPr>
        <p:grpSpPr>
          <a:xfrm>
            <a:off x="2592887" y="760721"/>
            <a:ext cx="6150953" cy="5804196"/>
            <a:chOff x="2592887" y="760721"/>
            <a:chExt cx="6150953" cy="5804196"/>
          </a:xfrm>
        </p:grpSpPr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xmlns="" id="{CAEC1C17-CD0F-4F1A-847A-974408A726C7}"/>
                </a:ext>
              </a:extLst>
            </p:cNvPr>
            <p:cNvGrpSpPr/>
            <p:nvPr/>
          </p:nvGrpSpPr>
          <p:grpSpPr>
            <a:xfrm>
              <a:off x="2592887" y="760721"/>
              <a:ext cx="6150953" cy="5804196"/>
              <a:chOff x="2846887" y="760721"/>
              <a:chExt cx="6150953" cy="5804196"/>
            </a:xfrm>
          </p:grpSpPr>
          <p:sp>
            <p:nvSpPr>
              <p:cNvPr id="2" name="object 2"/>
              <p:cNvSpPr txBox="1"/>
              <p:nvPr/>
            </p:nvSpPr>
            <p:spPr>
              <a:xfrm>
                <a:off x="3718086" y="6087834"/>
                <a:ext cx="112574" cy="19797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noAutofit/>
              </a:bodyPr>
              <a:lstStyle/>
              <a:p>
                <a:pPr marL="12940"/>
                <a:r>
                  <a:rPr sz="1223" dirty="0"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3" name="object 3"/>
              <p:cNvSpPr txBox="1"/>
              <p:nvPr/>
            </p:nvSpPr>
            <p:spPr>
              <a:xfrm>
                <a:off x="5152184" y="6087834"/>
                <a:ext cx="198623" cy="19797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noAutofit/>
              </a:bodyPr>
              <a:lstStyle/>
              <a:p>
                <a:pPr marL="12940"/>
                <a:r>
                  <a:rPr sz="1223" dirty="0">
                    <a:latin typeface="Arial"/>
                    <a:cs typeface="Arial"/>
                  </a:rPr>
                  <a:t>50</a:t>
                </a:r>
              </a:p>
            </p:txBody>
          </p:sp>
          <p:sp>
            <p:nvSpPr>
              <p:cNvPr id="4" name="object 4"/>
              <p:cNvSpPr txBox="1"/>
              <p:nvPr/>
            </p:nvSpPr>
            <p:spPr>
              <a:xfrm>
                <a:off x="6586283" y="6087834"/>
                <a:ext cx="285319" cy="19797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noAutofit/>
              </a:bodyPr>
              <a:lstStyle/>
              <a:p>
                <a:pPr marL="12940"/>
                <a:r>
                  <a:rPr sz="1223" dirty="0">
                    <a:latin typeface="Arial"/>
                    <a:cs typeface="Arial"/>
                  </a:rPr>
                  <a:t>100</a:t>
                </a:r>
              </a:p>
            </p:txBody>
          </p:sp>
          <p:sp>
            <p:nvSpPr>
              <p:cNvPr id="5" name="object 5"/>
              <p:cNvSpPr txBox="1"/>
              <p:nvPr/>
            </p:nvSpPr>
            <p:spPr>
              <a:xfrm>
                <a:off x="8063598" y="6087834"/>
                <a:ext cx="285319" cy="19797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noAutofit/>
              </a:bodyPr>
              <a:lstStyle/>
              <a:p>
                <a:pPr marL="12940"/>
                <a:r>
                  <a:rPr sz="1223" dirty="0">
                    <a:latin typeface="Arial"/>
                    <a:cs typeface="Arial"/>
                  </a:rPr>
                  <a:t>150</a:t>
                </a:r>
              </a:p>
            </p:txBody>
          </p:sp>
          <p:sp>
            <p:nvSpPr>
              <p:cNvPr id="20" name="object 20"/>
              <p:cNvSpPr txBox="1"/>
              <p:nvPr/>
            </p:nvSpPr>
            <p:spPr>
              <a:xfrm>
                <a:off x="5744884" y="6366941"/>
                <a:ext cx="984058" cy="197976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noAutofit/>
              </a:bodyPr>
              <a:lstStyle/>
              <a:p>
                <a:pPr marL="12940"/>
                <a:r>
                  <a:rPr sz="1223" dirty="0">
                    <a:latin typeface="Arial"/>
                    <a:cs typeface="Arial"/>
                  </a:rPr>
                  <a:t>Time(months)</a:t>
                </a:r>
              </a:p>
            </p:txBody>
          </p:sp>
          <p:sp>
            <p:nvSpPr>
              <p:cNvPr id="21" name="object 21"/>
              <p:cNvSpPr txBox="1"/>
              <p:nvPr/>
            </p:nvSpPr>
            <p:spPr>
              <a:xfrm>
                <a:off x="2846887" y="1932119"/>
                <a:ext cx="201988" cy="2804198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noAutofit/>
              </a:bodyPr>
              <a:lstStyle/>
              <a:p>
                <a:pPr marL="12940"/>
                <a:r>
                  <a:rPr lang="en-US" altLang="ko-KR" sz="1223" dirty="0">
                    <a:latin typeface="Arial"/>
                    <a:cs typeface="Arial"/>
                  </a:rPr>
                  <a:t>Recurrence-free survival (Probability)</a:t>
                </a:r>
              </a:p>
              <a:p>
                <a:pPr marL="12940"/>
                <a:endParaRPr sz="1223" dirty="0">
                  <a:latin typeface="Arial"/>
                  <a:cs typeface="Arial"/>
                </a:endParaRPr>
              </a:p>
            </p:txBody>
          </p:sp>
          <p:grpSp>
            <p:nvGrpSpPr>
              <p:cNvPr id="38" name="그룹 37">
                <a:extLst>
                  <a:ext uri="{FF2B5EF4-FFF2-40B4-BE49-F238E27FC236}">
                    <a16:creationId xmlns:a16="http://schemas.microsoft.com/office/drawing/2014/main" xmlns="" id="{67B811E1-E447-459D-8D2F-87667D2E33FD}"/>
                  </a:ext>
                </a:extLst>
              </p:cNvPr>
              <p:cNvGrpSpPr/>
              <p:nvPr/>
            </p:nvGrpSpPr>
            <p:grpSpPr>
              <a:xfrm>
                <a:off x="3194419" y="760721"/>
                <a:ext cx="5803421" cy="5146994"/>
                <a:chOff x="3194419" y="760721"/>
                <a:chExt cx="5803421" cy="5146994"/>
              </a:xfrm>
            </p:grpSpPr>
            <p:sp>
              <p:nvSpPr>
                <p:cNvPr id="11" name="object 11"/>
                <p:cNvSpPr/>
                <p:nvPr/>
              </p:nvSpPr>
              <p:spPr>
                <a:xfrm>
                  <a:off x="3480127" y="1904453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grpSp>
              <p:nvGrpSpPr>
                <p:cNvPr id="37" name="그룹 36">
                  <a:extLst>
                    <a:ext uri="{FF2B5EF4-FFF2-40B4-BE49-F238E27FC236}">
                      <a16:creationId xmlns:a16="http://schemas.microsoft.com/office/drawing/2014/main" xmlns="" id="{2F203E31-ED74-43B1-BD92-56594F9531C1}"/>
                    </a:ext>
                  </a:extLst>
                </p:cNvPr>
                <p:cNvGrpSpPr/>
                <p:nvPr/>
              </p:nvGrpSpPr>
              <p:grpSpPr>
                <a:xfrm>
                  <a:off x="3194419" y="760721"/>
                  <a:ext cx="5803421" cy="5146994"/>
                  <a:chOff x="3194419" y="760721"/>
                  <a:chExt cx="5803421" cy="5146994"/>
                </a:xfrm>
              </p:grpSpPr>
              <p:sp>
                <p:nvSpPr>
                  <p:cNvPr id="9" name="object 9"/>
                  <p:cNvSpPr/>
                  <p:nvPr/>
                </p:nvSpPr>
                <p:spPr>
                  <a:xfrm>
                    <a:off x="3480127" y="3810848"/>
                    <a:ext cx="93164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91439">
                        <a:moveTo>
                          <a:pt x="91439" y="0"/>
                        </a:moveTo>
                        <a:lnTo>
                          <a:pt x="0" y="0"/>
                        </a:lnTo>
                      </a:path>
                    </a:pathLst>
                  </a:custGeom>
                  <a:ln w="9525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sp>
                <p:nvSpPr>
                  <p:cNvPr id="10" name="object 10"/>
                  <p:cNvSpPr/>
                  <p:nvPr/>
                </p:nvSpPr>
                <p:spPr>
                  <a:xfrm>
                    <a:off x="3480127" y="2857585"/>
                    <a:ext cx="93164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91439">
                        <a:moveTo>
                          <a:pt x="91439" y="0"/>
                        </a:moveTo>
                        <a:lnTo>
                          <a:pt x="0" y="0"/>
                        </a:lnTo>
                      </a:path>
                    </a:pathLst>
                  </a:custGeom>
                  <a:ln w="9525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>
                    <a:noAutofit/>
                  </a:bodyPr>
                  <a:lstStyle/>
                  <a:p>
                    <a:endParaRPr sz="1834"/>
                  </a:p>
                </p:txBody>
              </p:sp>
              <p:grpSp>
                <p:nvGrpSpPr>
                  <p:cNvPr id="36" name="그룹 35">
                    <a:extLst>
                      <a:ext uri="{FF2B5EF4-FFF2-40B4-BE49-F238E27FC236}">
                        <a16:creationId xmlns:a16="http://schemas.microsoft.com/office/drawing/2014/main" xmlns="" id="{FF4E4C9F-0453-4756-8FCA-6A15FE6B5510}"/>
                      </a:ext>
                    </a:extLst>
                  </p:cNvPr>
                  <p:cNvGrpSpPr/>
                  <p:nvPr/>
                </p:nvGrpSpPr>
                <p:grpSpPr>
                  <a:xfrm>
                    <a:off x="3194419" y="760721"/>
                    <a:ext cx="5803421" cy="5146994"/>
                    <a:chOff x="3194419" y="760721"/>
                    <a:chExt cx="5803421" cy="5146994"/>
                  </a:xfrm>
                </p:grpSpPr>
                <p:sp>
                  <p:nvSpPr>
                    <p:cNvPr id="14" name="object 14"/>
                    <p:cNvSpPr txBox="1"/>
                    <p:nvPr/>
                  </p:nvSpPr>
                  <p:spPr>
                    <a:xfrm>
                      <a:off x="3194419" y="4643124"/>
                      <a:ext cx="197976" cy="241971"/>
                    </a:xfrm>
                    <a:prstGeom prst="rect">
                      <a:avLst/>
                    </a:prstGeom>
                  </p:spPr>
                  <p:txBody>
                    <a:bodyPr vert="vert270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0.2</a:t>
                      </a:r>
                    </a:p>
                  </p:txBody>
                </p:sp>
                <p:grpSp>
                  <p:nvGrpSpPr>
                    <p:cNvPr id="35" name="그룹 34">
                      <a:extLst>
                        <a:ext uri="{FF2B5EF4-FFF2-40B4-BE49-F238E27FC236}">
                          <a16:creationId xmlns:a16="http://schemas.microsoft.com/office/drawing/2014/main" xmlns="" id="{77FD5DAA-A7EB-480B-AF52-E8467CC9BDC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194419" y="760721"/>
                      <a:ext cx="5803421" cy="5146994"/>
                      <a:chOff x="3194419" y="760721"/>
                      <a:chExt cx="5803421" cy="5146994"/>
                    </a:xfrm>
                  </p:grpSpPr>
                  <p:sp>
                    <p:nvSpPr>
                      <p:cNvPr id="7" name="object 7"/>
                      <p:cNvSpPr/>
                      <p:nvPr/>
                    </p:nvSpPr>
                    <p:spPr>
                      <a:xfrm>
                        <a:off x="3480127" y="5717112"/>
                        <a:ext cx="93164" cy="0"/>
                      </a:xfrm>
                      <a:custGeom>
                        <a:avLst/>
                        <a:gdLst/>
                        <a:ahLst/>
                        <a:cxnLst/>
                        <a:rect l="l" t="t" r="r" b="b"/>
                        <a:pathLst>
                          <a:path w="91439">
                            <a:moveTo>
                              <a:pt x="91439" y="0"/>
                            </a:moveTo>
                            <a:lnTo>
                              <a:pt x="0" y="0"/>
                            </a:lnTo>
                          </a:path>
                        </a:pathLst>
                      </a:custGeom>
                      <a:ln w="9525">
                        <a:solidFill>
                          <a:srgbClr val="000000"/>
                        </a:solidFill>
                      </a:ln>
                    </p:spPr>
                    <p:txBody>
                      <a:bodyPr wrap="square" lIns="0" tIns="0" rIns="0" bIns="0" rtlCol="0">
                        <a:noAutofit/>
                      </a:bodyPr>
                      <a:lstStyle/>
                      <a:p>
                        <a:endParaRPr sz="1834"/>
                      </a:p>
                    </p:txBody>
                  </p:sp>
                  <p:sp>
                    <p:nvSpPr>
                      <p:cNvPr id="8" name="object 8"/>
                      <p:cNvSpPr/>
                      <p:nvPr/>
                    </p:nvSpPr>
                    <p:spPr>
                      <a:xfrm>
                        <a:off x="3480127" y="4763981"/>
                        <a:ext cx="93164" cy="0"/>
                      </a:xfrm>
                      <a:custGeom>
                        <a:avLst/>
                        <a:gdLst/>
                        <a:ahLst/>
                        <a:cxnLst/>
                        <a:rect l="l" t="t" r="r" b="b"/>
                        <a:pathLst>
                          <a:path w="91439">
                            <a:moveTo>
                              <a:pt x="91439" y="0"/>
                            </a:moveTo>
                            <a:lnTo>
                              <a:pt x="0" y="0"/>
                            </a:lnTo>
                          </a:path>
                        </a:pathLst>
                      </a:custGeom>
                      <a:ln w="9525">
                        <a:solidFill>
                          <a:srgbClr val="000000"/>
                        </a:solidFill>
                      </a:ln>
                    </p:spPr>
                    <p:txBody>
                      <a:bodyPr wrap="square" lIns="0" tIns="0" rIns="0" bIns="0" rtlCol="0">
                        <a:noAutofit/>
                      </a:bodyPr>
                      <a:lstStyle/>
                      <a:p>
                        <a:endParaRPr sz="1834"/>
                      </a:p>
                    </p:txBody>
                  </p:sp>
                  <p:sp>
                    <p:nvSpPr>
                      <p:cNvPr id="12" name="object 12"/>
                      <p:cNvSpPr/>
                      <p:nvPr/>
                    </p:nvSpPr>
                    <p:spPr>
                      <a:xfrm>
                        <a:off x="3480127" y="951320"/>
                        <a:ext cx="93164" cy="0"/>
                      </a:xfrm>
                      <a:custGeom>
                        <a:avLst/>
                        <a:gdLst/>
                        <a:ahLst/>
                        <a:cxnLst/>
                        <a:rect l="l" t="t" r="r" b="b"/>
                        <a:pathLst>
                          <a:path w="91439">
                            <a:moveTo>
                              <a:pt x="91439" y="0"/>
                            </a:moveTo>
                            <a:lnTo>
                              <a:pt x="0" y="0"/>
                            </a:lnTo>
                          </a:path>
                        </a:pathLst>
                      </a:custGeom>
                      <a:ln w="9525">
                        <a:solidFill>
                          <a:srgbClr val="000000"/>
                        </a:solidFill>
                      </a:ln>
                    </p:spPr>
                    <p:txBody>
                      <a:bodyPr wrap="square" lIns="0" tIns="0" rIns="0" bIns="0" rtlCol="0">
                        <a:noAutofit/>
                      </a:bodyPr>
                      <a:lstStyle/>
                      <a:p>
                        <a:endParaRPr sz="1834"/>
                      </a:p>
                    </p:txBody>
                  </p:sp>
                  <p:grpSp>
                    <p:nvGrpSpPr>
                      <p:cNvPr id="34" name="그룹 33">
                        <a:extLst>
                          <a:ext uri="{FF2B5EF4-FFF2-40B4-BE49-F238E27FC236}">
                            <a16:creationId xmlns:a16="http://schemas.microsoft.com/office/drawing/2014/main" xmlns="" id="{E89DBA0B-B196-41AC-ABD8-87886A68E8C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94419" y="760721"/>
                        <a:ext cx="5803421" cy="5146994"/>
                        <a:chOff x="3194419" y="760721"/>
                        <a:chExt cx="5803421" cy="5146994"/>
                      </a:xfrm>
                    </p:grpSpPr>
                    <p:sp>
                      <p:nvSpPr>
                        <p:cNvPr id="13" name="object 13"/>
                        <p:cNvSpPr txBox="1"/>
                        <p:nvPr/>
                      </p:nvSpPr>
                      <p:spPr>
                        <a:xfrm>
                          <a:off x="3194419" y="5596256"/>
                          <a:ext cx="197976" cy="241971"/>
                        </a:xfrm>
                        <a:prstGeom prst="rect">
                          <a:avLst/>
                        </a:prstGeom>
                      </p:spPr>
                      <p:txBody>
                        <a:bodyPr vert="vert270" wrap="square" lIns="0" tIns="0" rIns="0" bIns="0" rtlCol="0">
                          <a:noAutofit/>
                        </a:bodyPr>
                        <a:lstStyle/>
                        <a:p>
                          <a:pPr marL="12940"/>
                          <a:r>
                            <a:rPr sz="1223" dirty="0">
                              <a:latin typeface="Arial"/>
                              <a:cs typeface="Arial"/>
                            </a:rPr>
                            <a:t>0.0</a:t>
                          </a:r>
                        </a:p>
                      </p:txBody>
                    </p:sp>
                    <p:sp>
                      <p:nvSpPr>
                        <p:cNvPr id="15" name="object 15"/>
                        <p:cNvSpPr txBox="1"/>
                        <p:nvPr/>
                      </p:nvSpPr>
                      <p:spPr>
                        <a:xfrm>
                          <a:off x="3194419" y="3689992"/>
                          <a:ext cx="197976" cy="241971"/>
                        </a:xfrm>
                        <a:prstGeom prst="rect">
                          <a:avLst/>
                        </a:prstGeom>
                      </p:spPr>
                      <p:txBody>
                        <a:bodyPr vert="vert270" wrap="square" lIns="0" tIns="0" rIns="0" bIns="0" rtlCol="0">
                          <a:noAutofit/>
                        </a:bodyPr>
                        <a:lstStyle/>
                        <a:p>
                          <a:pPr marL="12940"/>
                          <a:r>
                            <a:rPr sz="1223" dirty="0">
                              <a:latin typeface="Arial"/>
                              <a:cs typeface="Arial"/>
                            </a:rPr>
                            <a:t>0.4</a:t>
                          </a:r>
                        </a:p>
                      </p:txBody>
                    </p:sp>
                    <p:sp>
                      <p:nvSpPr>
                        <p:cNvPr id="16" name="object 16"/>
                        <p:cNvSpPr txBox="1"/>
                        <p:nvPr/>
                      </p:nvSpPr>
                      <p:spPr>
                        <a:xfrm>
                          <a:off x="3194419" y="2736730"/>
                          <a:ext cx="197976" cy="241971"/>
                        </a:xfrm>
                        <a:prstGeom prst="rect">
                          <a:avLst/>
                        </a:prstGeom>
                      </p:spPr>
                      <p:txBody>
                        <a:bodyPr vert="vert270" wrap="square" lIns="0" tIns="0" rIns="0" bIns="0" rtlCol="0">
                          <a:noAutofit/>
                        </a:bodyPr>
                        <a:lstStyle/>
                        <a:p>
                          <a:pPr marL="12940"/>
                          <a:r>
                            <a:rPr sz="1223" dirty="0">
                              <a:latin typeface="Arial"/>
                              <a:cs typeface="Arial"/>
                            </a:rPr>
                            <a:t>0.6</a:t>
                          </a:r>
                          <a:endParaRPr sz="1223">
                            <a:latin typeface="Arial"/>
                            <a:cs typeface="Arial"/>
                          </a:endParaRPr>
                        </a:p>
                      </p:txBody>
                    </p:sp>
                    <p:sp>
                      <p:nvSpPr>
                        <p:cNvPr id="17" name="object 17"/>
                        <p:cNvSpPr txBox="1"/>
                        <p:nvPr/>
                      </p:nvSpPr>
                      <p:spPr>
                        <a:xfrm>
                          <a:off x="3194419" y="1783597"/>
                          <a:ext cx="197976" cy="241971"/>
                        </a:xfrm>
                        <a:prstGeom prst="rect">
                          <a:avLst/>
                        </a:prstGeom>
                      </p:spPr>
                      <p:txBody>
                        <a:bodyPr vert="vert270" wrap="square" lIns="0" tIns="0" rIns="0" bIns="0" rtlCol="0">
                          <a:noAutofit/>
                        </a:bodyPr>
                        <a:lstStyle/>
                        <a:p>
                          <a:pPr marL="12940"/>
                          <a:r>
                            <a:rPr sz="1223" dirty="0">
                              <a:latin typeface="Arial"/>
                              <a:cs typeface="Arial"/>
                            </a:rPr>
                            <a:t>0.8</a:t>
                          </a:r>
                          <a:endParaRPr sz="1223">
                            <a:latin typeface="Arial"/>
                            <a:cs typeface="Arial"/>
                          </a:endParaRPr>
                        </a:p>
                      </p:txBody>
                    </p:sp>
                    <p:sp>
                      <p:nvSpPr>
                        <p:cNvPr id="18" name="object 18"/>
                        <p:cNvSpPr txBox="1"/>
                        <p:nvPr/>
                      </p:nvSpPr>
                      <p:spPr>
                        <a:xfrm>
                          <a:off x="3194419" y="830465"/>
                          <a:ext cx="197976" cy="241971"/>
                        </a:xfrm>
                        <a:prstGeom prst="rect">
                          <a:avLst/>
                        </a:prstGeom>
                      </p:spPr>
                      <p:txBody>
                        <a:bodyPr vert="vert270" wrap="square" lIns="0" tIns="0" rIns="0" bIns="0" rtlCol="0">
                          <a:noAutofit/>
                        </a:bodyPr>
                        <a:lstStyle/>
                        <a:p>
                          <a:pPr marL="12940"/>
                          <a:r>
                            <a:rPr sz="1223" dirty="0">
                              <a:latin typeface="Arial"/>
                              <a:cs typeface="Arial"/>
                            </a:rPr>
                            <a:t>1.0</a:t>
                          </a:r>
                          <a:endParaRPr sz="1223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33" name="그룹 32">
                          <a:extLst>
                            <a:ext uri="{FF2B5EF4-FFF2-40B4-BE49-F238E27FC236}">
                              <a16:creationId xmlns:a16="http://schemas.microsoft.com/office/drawing/2014/main" xmlns="" id="{80F7679A-8B44-4768-A15C-BA0F6D60859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573291" y="760721"/>
                          <a:ext cx="5424549" cy="5146994"/>
                          <a:chOff x="3573291" y="760721"/>
                          <a:chExt cx="5424549" cy="5146994"/>
                        </a:xfrm>
                      </p:grpSpPr>
                      <p:sp>
                        <p:nvSpPr>
                          <p:cNvPr id="26" name="object 26"/>
                          <p:cNvSpPr/>
                          <p:nvPr/>
                        </p:nvSpPr>
                        <p:spPr>
                          <a:xfrm>
                            <a:off x="7528545" y="947051"/>
                            <a:ext cx="279496" cy="0"/>
                          </a:xfrm>
                          <a:custGeom>
                            <a:avLst/>
                            <a:gdLst/>
                            <a:ahLst/>
                            <a:cxnLst/>
                            <a:rect l="l" t="t" r="r" b="b"/>
                            <a:pathLst>
                              <a:path w="274320">
                                <a:moveTo>
                                  <a:pt x="0" y="0"/>
                                </a:moveTo>
                                <a:lnTo>
                                  <a:pt x="274320" y="0"/>
                                </a:lnTo>
                              </a:path>
                            </a:pathLst>
                          </a:custGeom>
                          <a:ln w="19050">
                            <a:solidFill>
                              <a:srgbClr val="7030A0"/>
                            </a:solidFill>
                          </a:ln>
                        </p:spPr>
                        <p:txBody>
                          <a:bodyPr wrap="square" lIns="0" tIns="0" rIns="0" bIns="0" rtlCol="0">
                            <a:noAutofit/>
                          </a:bodyPr>
                          <a:lstStyle/>
                          <a:p>
                            <a:endParaRPr sz="1834"/>
                          </a:p>
                        </p:txBody>
                      </p:sp>
                      <p:sp>
                        <p:nvSpPr>
                          <p:cNvPr id="27" name="object 27"/>
                          <p:cNvSpPr/>
                          <p:nvPr/>
                        </p:nvSpPr>
                        <p:spPr>
                          <a:xfrm>
                            <a:off x="7528545" y="1133381"/>
                            <a:ext cx="279496" cy="0"/>
                          </a:xfrm>
                          <a:custGeom>
                            <a:avLst/>
                            <a:gdLst/>
                            <a:ahLst/>
                            <a:cxnLst/>
                            <a:rect l="l" t="t" r="r" b="b"/>
                            <a:pathLst>
                              <a:path w="274320">
                                <a:moveTo>
                                  <a:pt x="0" y="0"/>
                                </a:moveTo>
                                <a:lnTo>
                                  <a:pt x="274320" y="0"/>
                                </a:lnTo>
                              </a:path>
                            </a:pathLst>
                          </a:custGeom>
                          <a:ln w="19050">
                            <a:solidFill>
                              <a:schemeClr val="accent6"/>
                            </a:solidFill>
                          </a:ln>
                        </p:spPr>
                        <p:txBody>
                          <a:bodyPr wrap="square" lIns="0" tIns="0" rIns="0" bIns="0" rtlCol="0">
                            <a:noAutofit/>
                          </a:bodyPr>
                          <a:lstStyle/>
                          <a:p>
                            <a:endParaRPr sz="1834"/>
                          </a:p>
                        </p:txBody>
                      </p:sp>
                      <p:grpSp>
                        <p:nvGrpSpPr>
                          <p:cNvPr id="32" name="그룹 31">
                            <a:extLst>
                              <a:ext uri="{FF2B5EF4-FFF2-40B4-BE49-F238E27FC236}">
                                <a16:creationId xmlns:a16="http://schemas.microsoft.com/office/drawing/2014/main" xmlns="" id="{4CD5D127-8F1D-4ACD-9F0F-F0F41F3CBEDB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3573291" y="760721"/>
                            <a:ext cx="5424549" cy="5146994"/>
                            <a:chOff x="3573291" y="760721"/>
                            <a:chExt cx="5424549" cy="5146994"/>
                          </a:xfrm>
                        </p:grpSpPr>
                        <p:grpSp>
                          <p:nvGrpSpPr>
                            <p:cNvPr id="31" name="그룹 30">
                              <a:extLst>
                                <a:ext uri="{FF2B5EF4-FFF2-40B4-BE49-F238E27FC236}">
                                  <a16:creationId xmlns:a16="http://schemas.microsoft.com/office/drawing/2014/main" xmlns="" id="{988D1EFB-2C73-488D-BC17-BA0F0E1E1C53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3573291" y="760721"/>
                              <a:ext cx="5424549" cy="5146994"/>
                              <a:chOff x="3573291" y="760721"/>
                              <a:chExt cx="5424549" cy="5146994"/>
                            </a:xfrm>
                          </p:grpSpPr>
                          <p:sp>
                            <p:nvSpPr>
                              <p:cNvPr id="19" name="object 19"/>
                              <p:cNvSpPr/>
                              <p:nvPr/>
                            </p:nvSpPr>
                            <p:spPr>
                              <a:xfrm>
                                <a:off x="3573291" y="760721"/>
                                <a:ext cx="5424549" cy="5146994"/>
                              </a:xfrm>
                              <a:custGeom>
                                <a:avLst/>
                                <a:gdLst/>
                                <a:ahLst/>
                                <a:cxnLst/>
                                <a:rect l="l" t="t" r="r" b="b"/>
                                <a:pathLst>
                                  <a:path w="5324094" h="5051679">
                                    <a:moveTo>
                                      <a:pt x="0" y="5051679"/>
                                    </a:moveTo>
                                    <a:lnTo>
                                      <a:pt x="5324094" y="5051679"/>
                                    </a:lnTo>
                                    <a:lnTo>
                                      <a:pt x="5324094" y="0"/>
                                    </a:lnTo>
                                    <a:lnTo>
                                      <a:pt x="0" y="0"/>
                                    </a:lnTo>
                                    <a:lnTo>
                                      <a:pt x="0" y="5051679"/>
                                    </a:lnTo>
                                  </a:path>
                                </a:pathLst>
                              </a:custGeom>
                              <a:ln w="9524">
                                <a:solidFill>
                                  <a:srgbClr val="000000"/>
                                </a:solidFill>
                              </a:ln>
                            </p:spPr>
                            <p:txBody>
                              <a:bodyPr wrap="square" lIns="0" tIns="0" rIns="0" bIns="0" rtlCol="0">
                                <a:noAutofit/>
                              </a:bodyPr>
                              <a:lstStyle/>
                              <a:p>
                                <a:endParaRPr sz="1834"/>
                              </a:p>
                            </p:txBody>
                          </p:sp>
                          <p:sp>
                            <p:nvSpPr>
                              <p:cNvPr id="22" name="object 22"/>
                              <p:cNvSpPr/>
                              <p:nvPr/>
                            </p:nvSpPr>
                            <p:spPr>
                              <a:xfrm>
                                <a:off x="3774243" y="951320"/>
                                <a:ext cx="4674050" cy="1462436"/>
                              </a:xfrm>
                              <a:custGeom>
                                <a:avLst/>
                                <a:gdLst/>
                                <a:ahLst/>
                                <a:cxnLst/>
                                <a:rect l="l" t="t" r="r" b="b"/>
                                <a:pathLst>
                                  <a:path w="4587494" h="1435354">
                                    <a:moveTo>
                                      <a:pt x="0" y="0"/>
                                    </a:moveTo>
                                    <a:lnTo>
                                      <a:pt x="95631" y="0"/>
                                    </a:lnTo>
                                    <a:lnTo>
                                      <a:pt x="95631" y="32512"/>
                                    </a:lnTo>
                                    <a:lnTo>
                                      <a:pt x="98552" y="32512"/>
                                    </a:lnTo>
                                    <a:lnTo>
                                      <a:pt x="98552" y="97536"/>
                                    </a:lnTo>
                                    <a:lnTo>
                                      <a:pt x="107188" y="97536"/>
                                    </a:lnTo>
                                    <a:lnTo>
                                      <a:pt x="107188" y="129921"/>
                                    </a:lnTo>
                                    <a:lnTo>
                                      <a:pt x="182626" y="129921"/>
                                    </a:lnTo>
                                    <a:lnTo>
                                      <a:pt x="182626" y="162433"/>
                                    </a:lnTo>
                                    <a:lnTo>
                                      <a:pt x="208788" y="162433"/>
                                    </a:lnTo>
                                    <a:lnTo>
                                      <a:pt x="208788" y="195199"/>
                                    </a:lnTo>
                                    <a:lnTo>
                                      <a:pt x="228981" y="195199"/>
                                    </a:lnTo>
                                    <a:lnTo>
                                      <a:pt x="228981" y="227837"/>
                                    </a:lnTo>
                                    <a:lnTo>
                                      <a:pt x="249301" y="227837"/>
                                    </a:lnTo>
                                    <a:lnTo>
                                      <a:pt x="249301" y="260604"/>
                                    </a:lnTo>
                                    <a:lnTo>
                                      <a:pt x="284099" y="260604"/>
                                    </a:lnTo>
                                    <a:lnTo>
                                      <a:pt x="284099" y="293497"/>
                                    </a:lnTo>
                                    <a:lnTo>
                                      <a:pt x="324739" y="293497"/>
                                    </a:lnTo>
                                    <a:lnTo>
                                      <a:pt x="324739" y="326771"/>
                                    </a:lnTo>
                                    <a:lnTo>
                                      <a:pt x="342138" y="326771"/>
                                    </a:lnTo>
                                    <a:lnTo>
                                      <a:pt x="342138" y="360045"/>
                                    </a:lnTo>
                                    <a:lnTo>
                                      <a:pt x="356616" y="360045"/>
                                    </a:lnTo>
                                    <a:lnTo>
                                      <a:pt x="356616" y="393446"/>
                                    </a:lnTo>
                                    <a:lnTo>
                                      <a:pt x="368173" y="393446"/>
                                    </a:lnTo>
                                    <a:lnTo>
                                      <a:pt x="368173" y="426974"/>
                                    </a:lnTo>
                                    <a:lnTo>
                                      <a:pt x="400177" y="426974"/>
                                    </a:lnTo>
                                    <a:lnTo>
                                      <a:pt x="400177" y="460375"/>
                                    </a:lnTo>
                                    <a:lnTo>
                                      <a:pt x="429133" y="460375"/>
                                    </a:lnTo>
                                    <a:lnTo>
                                      <a:pt x="429133" y="493903"/>
                                    </a:lnTo>
                                    <a:lnTo>
                                      <a:pt x="449453" y="493903"/>
                                    </a:lnTo>
                                    <a:lnTo>
                                      <a:pt x="449453" y="527304"/>
                                    </a:lnTo>
                                    <a:lnTo>
                                      <a:pt x="545084" y="527304"/>
                                    </a:lnTo>
                                    <a:lnTo>
                                      <a:pt x="545084" y="561340"/>
                                    </a:lnTo>
                                    <a:lnTo>
                                      <a:pt x="574167" y="561340"/>
                                    </a:lnTo>
                                    <a:lnTo>
                                      <a:pt x="574167" y="595630"/>
                                    </a:lnTo>
                                    <a:lnTo>
                                      <a:pt x="603123" y="595630"/>
                                    </a:lnTo>
                                    <a:lnTo>
                                      <a:pt x="603123" y="629920"/>
                                    </a:lnTo>
                                    <a:lnTo>
                                      <a:pt x="672719" y="629920"/>
                                    </a:lnTo>
                                    <a:lnTo>
                                      <a:pt x="672719" y="664845"/>
                                    </a:lnTo>
                                    <a:lnTo>
                                      <a:pt x="693038" y="664845"/>
                                    </a:lnTo>
                                    <a:lnTo>
                                      <a:pt x="693038" y="699770"/>
                                    </a:lnTo>
                                    <a:lnTo>
                                      <a:pt x="704596" y="699770"/>
                                    </a:lnTo>
                                    <a:lnTo>
                                      <a:pt x="704596" y="735203"/>
                                    </a:lnTo>
                                    <a:lnTo>
                                      <a:pt x="707517" y="735203"/>
                                    </a:lnTo>
                                    <a:lnTo>
                                      <a:pt x="707517" y="770763"/>
                                    </a:lnTo>
                                    <a:lnTo>
                                      <a:pt x="716153" y="770763"/>
                                    </a:lnTo>
                                    <a:lnTo>
                                      <a:pt x="716153" y="806576"/>
                                    </a:lnTo>
                                    <a:lnTo>
                                      <a:pt x="753872" y="806576"/>
                                    </a:lnTo>
                                    <a:lnTo>
                                      <a:pt x="753872" y="842391"/>
                                    </a:lnTo>
                                    <a:lnTo>
                                      <a:pt x="788669" y="842391"/>
                                    </a:lnTo>
                                    <a:lnTo>
                                      <a:pt x="788669" y="878332"/>
                                    </a:lnTo>
                                    <a:lnTo>
                                      <a:pt x="901827" y="878332"/>
                                    </a:lnTo>
                                    <a:lnTo>
                                      <a:pt x="901827" y="915543"/>
                                    </a:lnTo>
                                    <a:lnTo>
                                      <a:pt x="1072896" y="915543"/>
                                    </a:lnTo>
                                    <a:lnTo>
                                      <a:pt x="1072896" y="955548"/>
                                    </a:lnTo>
                                    <a:lnTo>
                                      <a:pt x="1075817" y="955548"/>
                                    </a:lnTo>
                                    <a:lnTo>
                                      <a:pt x="1075817" y="995553"/>
                                    </a:lnTo>
                                    <a:lnTo>
                                      <a:pt x="1229487" y="995553"/>
                                    </a:lnTo>
                                    <a:lnTo>
                                      <a:pt x="1229487" y="1038860"/>
                                    </a:lnTo>
                                    <a:lnTo>
                                      <a:pt x="1307719" y="1038860"/>
                                    </a:lnTo>
                                    <a:lnTo>
                                      <a:pt x="1307719" y="1083818"/>
                                    </a:lnTo>
                                    <a:lnTo>
                                      <a:pt x="1388999" y="1083818"/>
                                    </a:lnTo>
                                    <a:lnTo>
                                      <a:pt x="1388999" y="1129919"/>
                                    </a:lnTo>
                                    <a:lnTo>
                                      <a:pt x="1545590" y="1129919"/>
                                    </a:lnTo>
                                    <a:lnTo>
                                      <a:pt x="1545590" y="1179830"/>
                                    </a:lnTo>
                                    <a:lnTo>
                                      <a:pt x="1560068" y="1179830"/>
                                    </a:lnTo>
                                    <a:lnTo>
                                      <a:pt x="1560068" y="1230503"/>
                                    </a:lnTo>
                                    <a:lnTo>
                                      <a:pt x="1661541" y="1230503"/>
                                    </a:lnTo>
                                    <a:lnTo>
                                      <a:pt x="1661541" y="1284351"/>
                                    </a:lnTo>
                                    <a:lnTo>
                                      <a:pt x="1693418" y="1284351"/>
                                    </a:lnTo>
                                    <a:lnTo>
                                      <a:pt x="1693418" y="1339977"/>
                                    </a:lnTo>
                                    <a:lnTo>
                                      <a:pt x="2490851" y="1339977"/>
                                    </a:lnTo>
                                    <a:lnTo>
                                      <a:pt x="2490851" y="1435354"/>
                                    </a:lnTo>
                                    <a:lnTo>
                                      <a:pt x="4587494" y="1435354"/>
                                    </a:lnTo>
                                  </a:path>
                                </a:pathLst>
                              </a:custGeom>
                              <a:ln w="19050">
                                <a:solidFill>
                                  <a:srgbClr val="7030A0"/>
                                </a:solidFill>
                              </a:ln>
                            </p:spPr>
                            <p:txBody>
                              <a:bodyPr wrap="square" lIns="0" tIns="0" rIns="0" bIns="0" rtlCol="0">
                                <a:noAutofit/>
                              </a:bodyPr>
                              <a:lstStyle/>
                              <a:p>
                                <a:endParaRPr sz="1834"/>
                              </a:p>
                            </p:txBody>
                          </p:sp>
                        </p:grpSp>
                        <p:sp>
                          <p:nvSpPr>
                            <p:cNvPr id="23" name="object 23"/>
                            <p:cNvSpPr/>
                            <p:nvPr/>
                          </p:nvSpPr>
                          <p:spPr>
                            <a:xfrm>
                              <a:off x="3774242" y="951321"/>
                              <a:ext cx="3746280" cy="2190290"/>
                            </a:xfrm>
                            <a:custGeom>
                              <a:avLst/>
                              <a:gdLst/>
                              <a:ahLst/>
                              <a:cxnLst/>
                              <a:rect l="l" t="t" r="r" b="b"/>
                              <a:pathLst>
                                <a:path w="3676904" h="2149729">
                                  <a:moveTo>
                                    <a:pt x="0" y="0"/>
                                  </a:moveTo>
                                  <a:lnTo>
                                    <a:pt x="43434" y="0"/>
                                  </a:lnTo>
                                  <a:lnTo>
                                    <a:pt x="43434" y="69850"/>
                                  </a:lnTo>
                                  <a:lnTo>
                                    <a:pt x="60833" y="69850"/>
                                  </a:lnTo>
                                  <a:lnTo>
                                    <a:pt x="60833" y="139700"/>
                                  </a:lnTo>
                                  <a:lnTo>
                                    <a:pt x="63754" y="139700"/>
                                  </a:lnTo>
                                  <a:lnTo>
                                    <a:pt x="63754" y="209423"/>
                                  </a:lnTo>
                                  <a:lnTo>
                                    <a:pt x="72390" y="209423"/>
                                  </a:lnTo>
                                  <a:lnTo>
                                    <a:pt x="72390" y="279273"/>
                                  </a:lnTo>
                                  <a:lnTo>
                                    <a:pt x="92710" y="279273"/>
                                  </a:lnTo>
                                  <a:lnTo>
                                    <a:pt x="92710" y="349123"/>
                                  </a:lnTo>
                                  <a:lnTo>
                                    <a:pt x="113030" y="349123"/>
                                  </a:lnTo>
                                  <a:lnTo>
                                    <a:pt x="113030" y="418973"/>
                                  </a:lnTo>
                                  <a:lnTo>
                                    <a:pt x="136271" y="418973"/>
                                  </a:lnTo>
                                  <a:lnTo>
                                    <a:pt x="136271" y="488696"/>
                                  </a:lnTo>
                                  <a:lnTo>
                                    <a:pt x="176784" y="488696"/>
                                  </a:lnTo>
                                  <a:lnTo>
                                    <a:pt x="176784" y="559688"/>
                                  </a:lnTo>
                                  <a:lnTo>
                                    <a:pt x="188468" y="559688"/>
                                  </a:lnTo>
                                  <a:lnTo>
                                    <a:pt x="188468" y="631951"/>
                                  </a:lnTo>
                                  <a:lnTo>
                                    <a:pt x="197104" y="631951"/>
                                  </a:lnTo>
                                  <a:lnTo>
                                    <a:pt x="197104" y="704215"/>
                                  </a:lnTo>
                                  <a:lnTo>
                                    <a:pt x="214503" y="704215"/>
                                  </a:lnTo>
                                  <a:lnTo>
                                    <a:pt x="214503" y="776478"/>
                                  </a:lnTo>
                                  <a:lnTo>
                                    <a:pt x="231902" y="776478"/>
                                  </a:lnTo>
                                  <a:lnTo>
                                    <a:pt x="231902" y="848741"/>
                                  </a:lnTo>
                                  <a:lnTo>
                                    <a:pt x="275463" y="848741"/>
                                  </a:lnTo>
                                  <a:lnTo>
                                    <a:pt x="275463" y="920876"/>
                                  </a:lnTo>
                                  <a:lnTo>
                                    <a:pt x="295783" y="920876"/>
                                  </a:lnTo>
                                  <a:lnTo>
                                    <a:pt x="295783" y="993140"/>
                                  </a:lnTo>
                                  <a:lnTo>
                                    <a:pt x="342138" y="993140"/>
                                  </a:lnTo>
                                  <a:lnTo>
                                    <a:pt x="342138" y="1066800"/>
                                  </a:lnTo>
                                  <a:lnTo>
                                    <a:pt x="345059" y="1066800"/>
                                  </a:lnTo>
                                  <a:lnTo>
                                    <a:pt x="345059" y="1140587"/>
                                  </a:lnTo>
                                  <a:lnTo>
                                    <a:pt x="350774" y="1140587"/>
                                  </a:lnTo>
                                  <a:lnTo>
                                    <a:pt x="350774" y="1214247"/>
                                  </a:lnTo>
                                  <a:lnTo>
                                    <a:pt x="353695" y="1214247"/>
                                  </a:lnTo>
                                  <a:lnTo>
                                    <a:pt x="353695" y="1287907"/>
                                  </a:lnTo>
                                  <a:lnTo>
                                    <a:pt x="495808" y="1287907"/>
                                  </a:lnTo>
                                  <a:lnTo>
                                    <a:pt x="495808" y="1361567"/>
                                  </a:lnTo>
                                  <a:lnTo>
                                    <a:pt x="501650" y="1361567"/>
                                  </a:lnTo>
                                  <a:lnTo>
                                    <a:pt x="501650" y="1435354"/>
                                  </a:lnTo>
                                  <a:lnTo>
                                    <a:pt x="516128" y="1435354"/>
                                  </a:lnTo>
                                  <a:lnTo>
                                    <a:pt x="516128" y="1509014"/>
                                  </a:lnTo>
                                  <a:lnTo>
                                    <a:pt x="519049" y="1509014"/>
                                  </a:lnTo>
                                  <a:lnTo>
                                    <a:pt x="519049" y="1582674"/>
                                  </a:lnTo>
                                  <a:lnTo>
                                    <a:pt x="521970" y="1582674"/>
                                  </a:lnTo>
                                  <a:lnTo>
                                    <a:pt x="521970" y="1656334"/>
                                  </a:lnTo>
                                  <a:lnTo>
                                    <a:pt x="588645" y="1656334"/>
                                  </a:lnTo>
                                  <a:lnTo>
                                    <a:pt x="588645" y="1731899"/>
                                  </a:lnTo>
                                  <a:lnTo>
                                    <a:pt x="704596" y="1731899"/>
                                  </a:lnTo>
                                  <a:lnTo>
                                    <a:pt x="704596" y="1809369"/>
                                  </a:lnTo>
                                  <a:lnTo>
                                    <a:pt x="823468" y="1809369"/>
                                  </a:lnTo>
                                  <a:lnTo>
                                    <a:pt x="823468" y="1889125"/>
                                  </a:lnTo>
                                  <a:lnTo>
                                    <a:pt x="916305" y="1889125"/>
                                  </a:lnTo>
                                  <a:lnTo>
                                    <a:pt x="916305" y="1968754"/>
                                  </a:lnTo>
                                  <a:lnTo>
                                    <a:pt x="1209167" y="1968754"/>
                                  </a:lnTo>
                                  <a:lnTo>
                                    <a:pt x="1209167" y="2056130"/>
                                  </a:lnTo>
                                  <a:lnTo>
                                    <a:pt x="1307719" y="2056130"/>
                                  </a:lnTo>
                                  <a:lnTo>
                                    <a:pt x="1307719" y="2149729"/>
                                  </a:lnTo>
                                  <a:lnTo>
                                    <a:pt x="3676904" y="2149729"/>
                                  </a:lnTo>
                                </a:path>
                              </a:pathLst>
                            </a:custGeom>
                            <a:ln w="19050">
                              <a:solidFill>
                                <a:schemeClr val="accent6"/>
                              </a:solidFill>
                            </a:ln>
                          </p:spPr>
                          <p:txBody>
                            <a:bodyPr wrap="square" lIns="0" tIns="0" rIns="0" bIns="0" rtlCol="0">
                              <a:noAutofit/>
                            </a:bodyPr>
                            <a:lstStyle/>
                            <a:p>
                              <a:endParaRPr sz="1834"/>
                            </a:p>
                          </p:txBody>
                        </p:sp>
                        <p:sp>
                          <p:nvSpPr>
                            <p:cNvPr id="28" name="object 28"/>
                            <p:cNvSpPr txBox="1"/>
                            <p:nvPr/>
                          </p:nvSpPr>
                          <p:spPr>
                            <a:xfrm>
                              <a:off x="7934849" y="847545"/>
                              <a:ext cx="1044228" cy="384307"/>
                            </a:xfrm>
                            <a:prstGeom prst="rect">
                              <a:avLst/>
                            </a:prstGeom>
                          </p:spPr>
                          <p:txBody>
                            <a:bodyPr vert="horz" wrap="square" lIns="0" tIns="0" rIns="0" bIns="0" rtlCol="0">
                              <a:noAutofit/>
                            </a:bodyPr>
                            <a:lstStyle/>
                            <a:p>
                              <a:pPr marL="12940" marR="12940"/>
                              <a:r>
                                <a:rPr sz="1223" dirty="0">
                                  <a:latin typeface="Arial"/>
                                  <a:cs typeface="Arial"/>
                                </a:rPr>
                                <a:t>LC without IPF LC with IPF</a:t>
                              </a:r>
                              <a:endParaRPr sz="1223">
                                <a:latin typeface="Arial"/>
                                <a:cs typeface="Arial"/>
                              </a:endParaRPr>
                            </a:p>
                          </p:txBody>
                        </p:sp>
                      </p:grpSp>
                    </p:grpSp>
                  </p:grpSp>
                </p:grpSp>
              </p:grpSp>
            </p:grpSp>
          </p:grpSp>
        </p:grpSp>
        <p:sp>
          <p:nvSpPr>
            <p:cNvPr id="40" name="object 31">
              <a:extLst>
                <a:ext uri="{FF2B5EF4-FFF2-40B4-BE49-F238E27FC236}">
                  <a16:creationId xmlns:a16="http://schemas.microsoft.com/office/drawing/2014/main" xmlns="" id="{2BC7A023-3CB1-4859-BDA7-399F34B99B9C}"/>
                </a:ext>
              </a:extLst>
            </p:cNvPr>
            <p:cNvSpPr txBox="1"/>
            <p:nvPr/>
          </p:nvSpPr>
          <p:spPr>
            <a:xfrm>
              <a:off x="7266522" y="2697670"/>
              <a:ext cx="1220970" cy="264845"/>
            </a:xfrm>
            <a:prstGeom prst="rect">
              <a:avLst/>
            </a:prstGeom>
          </p:spPr>
          <p:txBody>
            <a:bodyPr vert="horz" wrap="square" lIns="0" tIns="0" rIns="0" bIns="0" rtlCol="0">
              <a:noAutofit/>
            </a:bodyPr>
            <a:lstStyle/>
            <a:p>
              <a:pPr marL="12701"/>
              <a:r>
                <a:rPr lang="en-US" sz="1200" dirty="0">
                  <a:latin typeface="Arial"/>
                  <a:cs typeface="Arial"/>
                </a:rPr>
                <a:t>P</a:t>
              </a:r>
              <a:r>
                <a:rPr sz="1200" dirty="0">
                  <a:latin typeface="Arial"/>
                  <a:cs typeface="Arial"/>
                </a:rPr>
                <a:t> </a:t>
              </a:r>
              <a:r>
                <a:rPr lang="en-US" altLang="ko-KR" sz="1200" dirty="0">
                  <a:latin typeface="Arial"/>
                  <a:cs typeface="Arial"/>
                </a:rPr>
                <a:t>=</a:t>
              </a:r>
              <a:r>
                <a:rPr sz="1200" dirty="0">
                  <a:latin typeface="Arial"/>
                  <a:cs typeface="Arial"/>
                </a:rPr>
                <a:t> 0.00</a:t>
              </a:r>
              <a:r>
                <a:rPr lang="en-US" altLang="ko-KR" sz="1200" dirty="0">
                  <a:latin typeface="Arial"/>
                  <a:cs typeface="Arial"/>
                </a:rPr>
                <a:t>3</a:t>
              </a:r>
              <a:endParaRPr sz="1200" dirty="0">
                <a:latin typeface="Arial"/>
                <a:cs typeface="Arial"/>
              </a:endParaRP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2B28858A-2BA4-42E3-B881-789ACFC1B184}"/>
              </a:ext>
            </a:extLst>
          </p:cNvPr>
          <p:cNvSpPr txBox="1"/>
          <p:nvPr/>
        </p:nvSpPr>
        <p:spPr>
          <a:xfrm>
            <a:off x="238124" y="142875"/>
            <a:ext cx="25233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2A Fig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그룹 33">
            <a:extLst>
              <a:ext uri="{FF2B5EF4-FFF2-40B4-BE49-F238E27FC236}">
                <a16:creationId xmlns:a16="http://schemas.microsoft.com/office/drawing/2014/main" xmlns="" id="{368EC07E-1AD8-4E4E-8982-46BE69143001}"/>
              </a:ext>
            </a:extLst>
          </p:cNvPr>
          <p:cNvGrpSpPr/>
          <p:nvPr/>
        </p:nvGrpSpPr>
        <p:grpSpPr>
          <a:xfrm>
            <a:off x="3016568" y="594892"/>
            <a:ext cx="6158863" cy="5897749"/>
            <a:chOff x="2838977" y="760721"/>
            <a:chExt cx="6158863" cy="5897749"/>
          </a:xfrm>
        </p:grpSpPr>
        <p:sp>
          <p:nvSpPr>
            <p:cNvPr id="13" name="object 13"/>
            <p:cNvSpPr txBox="1"/>
            <p:nvPr/>
          </p:nvSpPr>
          <p:spPr>
            <a:xfrm>
              <a:off x="3194419" y="5596256"/>
              <a:ext cx="197976" cy="241971"/>
            </a:xfrm>
            <a:prstGeom prst="rect">
              <a:avLst/>
            </a:prstGeom>
          </p:spPr>
          <p:txBody>
            <a:bodyPr vert="vert270" wrap="square" lIns="0" tIns="0" rIns="0" bIns="0" rtlCol="0">
              <a:noAutofit/>
            </a:bodyPr>
            <a:lstStyle/>
            <a:p>
              <a:pPr marL="12940"/>
              <a:r>
                <a:rPr sz="1223" dirty="0">
                  <a:latin typeface="Arial"/>
                  <a:cs typeface="Arial"/>
                </a:rPr>
                <a:t>0.0</a:t>
              </a:r>
            </a:p>
          </p:txBody>
        </p:sp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xmlns="" id="{5F07211C-6814-44DF-9EB0-6198CAB4C777}"/>
                </a:ext>
              </a:extLst>
            </p:cNvPr>
            <p:cNvGrpSpPr/>
            <p:nvPr/>
          </p:nvGrpSpPr>
          <p:grpSpPr>
            <a:xfrm>
              <a:off x="2838977" y="760721"/>
              <a:ext cx="6158863" cy="5897749"/>
              <a:chOff x="2838977" y="760721"/>
              <a:chExt cx="6158863" cy="5897749"/>
            </a:xfrm>
          </p:grpSpPr>
          <p:sp>
            <p:nvSpPr>
              <p:cNvPr id="22" name="object 22"/>
              <p:cNvSpPr/>
              <p:nvPr/>
            </p:nvSpPr>
            <p:spPr>
              <a:xfrm>
                <a:off x="3774243" y="951320"/>
                <a:ext cx="4674050" cy="1674258"/>
              </a:xfrm>
              <a:custGeom>
                <a:avLst/>
                <a:gdLst/>
                <a:ahLst/>
                <a:cxnLst/>
                <a:rect l="l" t="t" r="r" b="b"/>
                <a:pathLst>
                  <a:path w="4587494" h="1643253">
                    <a:moveTo>
                      <a:pt x="0" y="0"/>
                    </a:moveTo>
                    <a:lnTo>
                      <a:pt x="37592" y="0"/>
                    </a:lnTo>
                    <a:lnTo>
                      <a:pt x="37592" y="63246"/>
                    </a:lnTo>
                    <a:lnTo>
                      <a:pt x="43434" y="63246"/>
                    </a:lnTo>
                    <a:lnTo>
                      <a:pt x="43434" y="94869"/>
                    </a:lnTo>
                    <a:lnTo>
                      <a:pt x="86995" y="94869"/>
                    </a:lnTo>
                    <a:lnTo>
                      <a:pt x="86995" y="126492"/>
                    </a:lnTo>
                    <a:lnTo>
                      <a:pt x="188468" y="126492"/>
                    </a:lnTo>
                    <a:lnTo>
                      <a:pt x="188468" y="158115"/>
                    </a:lnTo>
                    <a:lnTo>
                      <a:pt x="272542" y="158115"/>
                    </a:lnTo>
                    <a:lnTo>
                      <a:pt x="272542" y="189865"/>
                    </a:lnTo>
                    <a:lnTo>
                      <a:pt x="321818" y="189865"/>
                    </a:lnTo>
                    <a:lnTo>
                      <a:pt x="321818" y="221996"/>
                    </a:lnTo>
                    <a:lnTo>
                      <a:pt x="359537" y="221996"/>
                    </a:lnTo>
                    <a:lnTo>
                      <a:pt x="359537" y="254254"/>
                    </a:lnTo>
                    <a:lnTo>
                      <a:pt x="432054" y="254254"/>
                    </a:lnTo>
                    <a:lnTo>
                      <a:pt x="432054" y="286512"/>
                    </a:lnTo>
                    <a:lnTo>
                      <a:pt x="507365" y="286512"/>
                    </a:lnTo>
                    <a:lnTo>
                      <a:pt x="507365" y="319024"/>
                    </a:lnTo>
                    <a:lnTo>
                      <a:pt x="623443" y="319024"/>
                    </a:lnTo>
                    <a:lnTo>
                      <a:pt x="623443" y="352298"/>
                    </a:lnTo>
                    <a:lnTo>
                      <a:pt x="629158" y="352298"/>
                    </a:lnTo>
                    <a:lnTo>
                      <a:pt x="629158" y="385572"/>
                    </a:lnTo>
                    <a:lnTo>
                      <a:pt x="649478" y="385572"/>
                    </a:lnTo>
                    <a:lnTo>
                      <a:pt x="649478" y="419100"/>
                    </a:lnTo>
                    <a:lnTo>
                      <a:pt x="695960" y="419100"/>
                    </a:lnTo>
                    <a:lnTo>
                      <a:pt x="695960" y="486156"/>
                    </a:lnTo>
                    <a:lnTo>
                      <a:pt x="713359" y="486156"/>
                    </a:lnTo>
                    <a:lnTo>
                      <a:pt x="713359" y="519684"/>
                    </a:lnTo>
                    <a:lnTo>
                      <a:pt x="794512" y="519684"/>
                    </a:lnTo>
                    <a:lnTo>
                      <a:pt x="794512" y="553212"/>
                    </a:lnTo>
                    <a:lnTo>
                      <a:pt x="806069" y="553212"/>
                    </a:lnTo>
                    <a:lnTo>
                      <a:pt x="806069" y="586994"/>
                    </a:lnTo>
                    <a:lnTo>
                      <a:pt x="852551" y="586994"/>
                    </a:lnTo>
                    <a:lnTo>
                      <a:pt x="852551" y="620903"/>
                    </a:lnTo>
                    <a:lnTo>
                      <a:pt x="913384" y="620903"/>
                    </a:lnTo>
                    <a:lnTo>
                      <a:pt x="913384" y="655193"/>
                    </a:lnTo>
                    <a:lnTo>
                      <a:pt x="924941" y="655193"/>
                    </a:lnTo>
                    <a:lnTo>
                      <a:pt x="924941" y="689610"/>
                    </a:lnTo>
                    <a:lnTo>
                      <a:pt x="936625" y="689610"/>
                    </a:lnTo>
                    <a:lnTo>
                      <a:pt x="936625" y="724026"/>
                    </a:lnTo>
                    <a:lnTo>
                      <a:pt x="991743" y="724026"/>
                    </a:lnTo>
                    <a:lnTo>
                      <a:pt x="991743" y="758951"/>
                    </a:lnTo>
                    <a:lnTo>
                      <a:pt x="1041019" y="758951"/>
                    </a:lnTo>
                    <a:lnTo>
                      <a:pt x="1041019" y="794258"/>
                    </a:lnTo>
                    <a:lnTo>
                      <a:pt x="1069975" y="794258"/>
                    </a:lnTo>
                    <a:lnTo>
                      <a:pt x="1069975" y="829563"/>
                    </a:lnTo>
                    <a:lnTo>
                      <a:pt x="1272921" y="829563"/>
                    </a:lnTo>
                    <a:lnTo>
                      <a:pt x="1272921" y="868426"/>
                    </a:lnTo>
                    <a:lnTo>
                      <a:pt x="1371600" y="868426"/>
                    </a:lnTo>
                    <a:lnTo>
                      <a:pt x="1371600" y="907288"/>
                    </a:lnTo>
                    <a:lnTo>
                      <a:pt x="1420876" y="907288"/>
                    </a:lnTo>
                    <a:lnTo>
                      <a:pt x="1420876" y="947420"/>
                    </a:lnTo>
                    <a:lnTo>
                      <a:pt x="1452753" y="947420"/>
                    </a:lnTo>
                    <a:lnTo>
                      <a:pt x="1452753" y="988822"/>
                    </a:lnTo>
                    <a:lnTo>
                      <a:pt x="1484630" y="988822"/>
                    </a:lnTo>
                    <a:lnTo>
                      <a:pt x="1484630" y="1030732"/>
                    </a:lnTo>
                    <a:lnTo>
                      <a:pt x="1542669" y="1030732"/>
                    </a:lnTo>
                    <a:lnTo>
                      <a:pt x="1542669" y="1073150"/>
                    </a:lnTo>
                    <a:lnTo>
                      <a:pt x="1583309" y="1073150"/>
                    </a:lnTo>
                    <a:lnTo>
                      <a:pt x="1583309" y="1116584"/>
                    </a:lnTo>
                    <a:lnTo>
                      <a:pt x="1618107" y="1116584"/>
                    </a:lnTo>
                    <a:lnTo>
                      <a:pt x="1618107" y="1161161"/>
                    </a:lnTo>
                    <a:lnTo>
                      <a:pt x="1658620" y="1161161"/>
                    </a:lnTo>
                    <a:lnTo>
                      <a:pt x="1658620" y="1206246"/>
                    </a:lnTo>
                    <a:lnTo>
                      <a:pt x="1661541" y="1206246"/>
                    </a:lnTo>
                    <a:lnTo>
                      <a:pt x="1661541" y="1251331"/>
                    </a:lnTo>
                    <a:lnTo>
                      <a:pt x="1690497" y="1251331"/>
                    </a:lnTo>
                    <a:lnTo>
                      <a:pt x="1690497" y="1297559"/>
                    </a:lnTo>
                    <a:lnTo>
                      <a:pt x="1699260" y="1297559"/>
                    </a:lnTo>
                    <a:lnTo>
                      <a:pt x="1699260" y="1343914"/>
                    </a:lnTo>
                    <a:lnTo>
                      <a:pt x="1919605" y="1343914"/>
                    </a:lnTo>
                    <a:lnTo>
                      <a:pt x="1919605" y="1394333"/>
                    </a:lnTo>
                    <a:lnTo>
                      <a:pt x="2224151" y="1394333"/>
                    </a:lnTo>
                    <a:lnTo>
                      <a:pt x="2224151" y="1456309"/>
                    </a:lnTo>
                    <a:lnTo>
                      <a:pt x="2511171" y="1456309"/>
                    </a:lnTo>
                    <a:lnTo>
                      <a:pt x="2511171" y="1534922"/>
                    </a:lnTo>
                    <a:lnTo>
                      <a:pt x="2754757" y="1534922"/>
                    </a:lnTo>
                    <a:lnTo>
                      <a:pt x="2754757" y="1643253"/>
                    </a:lnTo>
                    <a:lnTo>
                      <a:pt x="4587494" y="1643253"/>
                    </a:lnTo>
                  </a:path>
                </a:pathLst>
              </a:custGeom>
              <a:ln w="19050">
                <a:solidFill>
                  <a:srgbClr val="A020F0"/>
                </a:solidFill>
              </a:ln>
            </p:spPr>
            <p:txBody>
              <a:bodyPr wrap="square" lIns="0" tIns="0" rIns="0" bIns="0" rtlCol="0">
                <a:noAutofit/>
              </a:bodyPr>
              <a:lstStyle/>
              <a:p>
                <a:endParaRPr sz="1834"/>
              </a:p>
            </p:txBody>
          </p:sp>
          <p:sp>
            <p:nvSpPr>
              <p:cNvPr id="23" name="object 23"/>
              <p:cNvSpPr/>
              <p:nvPr/>
            </p:nvSpPr>
            <p:spPr>
              <a:xfrm>
                <a:off x="3774242" y="951321"/>
                <a:ext cx="3746280" cy="4249501"/>
              </a:xfrm>
              <a:custGeom>
                <a:avLst/>
                <a:gdLst/>
                <a:ahLst/>
                <a:cxnLst/>
                <a:rect l="l" t="t" r="r" b="b"/>
                <a:pathLst>
                  <a:path w="3676904" h="4170807">
                    <a:moveTo>
                      <a:pt x="0" y="0"/>
                    </a:moveTo>
                    <a:lnTo>
                      <a:pt x="14478" y="0"/>
                    </a:lnTo>
                    <a:lnTo>
                      <a:pt x="14478" y="66801"/>
                    </a:lnTo>
                    <a:lnTo>
                      <a:pt x="26035" y="66801"/>
                    </a:lnTo>
                    <a:lnTo>
                      <a:pt x="26035" y="133731"/>
                    </a:lnTo>
                    <a:lnTo>
                      <a:pt x="34798" y="133731"/>
                    </a:lnTo>
                    <a:lnTo>
                      <a:pt x="34798" y="200533"/>
                    </a:lnTo>
                    <a:lnTo>
                      <a:pt x="75311" y="200533"/>
                    </a:lnTo>
                    <a:lnTo>
                      <a:pt x="75311" y="334137"/>
                    </a:lnTo>
                    <a:lnTo>
                      <a:pt x="101473" y="334137"/>
                    </a:lnTo>
                    <a:lnTo>
                      <a:pt x="101473" y="400938"/>
                    </a:lnTo>
                    <a:lnTo>
                      <a:pt x="176784" y="400938"/>
                    </a:lnTo>
                    <a:lnTo>
                      <a:pt x="176784" y="468884"/>
                    </a:lnTo>
                    <a:lnTo>
                      <a:pt x="234823" y="468884"/>
                    </a:lnTo>
                    <a:lnTo>
                      <a:pt x="234823" y="536701"/>
                    </a:lnTo>
                    <a:lnTo>
                      <a:pt x="304419" y="536701"/>
                    </a:lnTo>
                    <a:lnTo>
                      <a:pt x="304419" y="604647"/>
                    </a:lnTo>
                    <a:lnTo>
                      <a:pt x="339217" y="604647"/>
                    </a:lnTo>
                    <a:lnTo>
                      <a:pt x="339217" y="672465"/>
                    </a:lnTo>
                    <a:lnTo>
                      <a:pt x="359537" y="672465"/>
                    </a:lnTo>
                    <a:lnTo>
                      <a:pt x="359537" y="740410"/>
                    </a:lnTo>
                    <a:lnTo>
                      <a:pt x="400177" y="740410"/>
                    </a:lnTo>
                    <a:lnTo>
                      <a:pt x="400177" y="808228"/>
                    </a:lnTo>
                    <a:lnTo>
                      <a:pt x="452374" y="808228"/>
                    </a:lnTo>
                    <a:lnTo>
                      <a:pt x="452374" y="876173"/>
                    </a:lnTo>
                    <a:lnTo>
                      <a:pt x="487172" y="876173"/>
                    </a:lnTo>
                    <a:lnTo>
                      <a:pt x="487172" y="1011936"/>
                    </a:lnTo>
                    <a:lnTo>
                      <a:pt x="504571" y="1011936"/>
                    </a:lnTo>
                    <a:lnTo>
                      <a:pt x="504571" y="1079754"/>
                    </a:lnTo>
                    <a:lnTo>
                      <a:pt x="574167" y="1079754"/>
                    </a:lnTo>
                    <a:lnTo>
                      <a:pt x="574167" y="1148969"/>
                    </a:lnTo>
                    <a:lnTo>
                      <a:pt x="620522" y="1148969"/>
                    </a:lnTo>
                    <a:lnTo>
                      <a:pt x="620522" y="1219581"/>
                    </a:lnTo>
                    <a:lnTo>
                      <a:pt x="637921" y="1219581"/>
                    </a:lnTo>
                    <a:lnTo>
                      <a:pt x="637921" y="1290066"/>
                    </a:lnTo>
                    <a:lnTo>
                      <a:pt x="687197" y="1290066"/>
                    </a:lnTo>
                    <a:lnTo>
                      <a:pt x="687197" y="1360678"/>
                    </a:lnTo>
                    <a:lnTo>
                      <a:pt x="701675" y="1360678"/>
                    </a:lnTo>
                    <a:lnTo>
                      <a:pt x="701675" y="1431290"/>
                    </a:lnTo>
                    <a:lnTo>
                      <a:pt x="806069" y="1431290"/>
                    </a:lnTo>
                    <a:lnTo>
                      <a:pt x="806069" y="1503426"/>
                    </a:lnTo>
                    <a:lnTo>
                      <a:pt x="835152" y="1503426"/>
                    </a:lnTo>
                    <a:lnTo>
                      <a:pt x="835152" y="1575562"/>
                    </a:lnTo>
                    <a:lnTo>
                      <a:pt x="864108" y="1575562"/>
                    </a:lnTo>
                    <a:lnTo>
                      <a:pt x="864108" y="1647698"/>
                    </a:lnTo>
                    <a:lnTo>
                      <a:pt x="954024" y="1647698"/>
                    </a:lnTo>
                    <a:lnTo>
                      <a:pt x="954024" y="1719834"/>
                    </a:lnTo>
                    <a:lnTo>
                      <a:pt x="991743" y="1719834"/>
                    </a:lnTo>
                    <a:lnTo>
                      <a:pt x="991743" y="1791970"/>
                    </a:lnTo>
                    <a:lnTo>
                      <a:pt x="1046734" y="1791970"/>
                    </a:lnTo>
                    <a:lnTo>
                      <a:pt x="1046734" y="1864106"/>
                    </a:lnTo>
                    <a:lnTo>
                      <a:pt x="1159891" y="1864106"/>
                    </a:lnTo>
                    <a:lnTo>
                      <a:pt x="1159891" y="1936242"/>
                    </a:lnTo>
                    <a:lnTo>
                      <a:pt x="1313561" y="1936242"/>
                    </a:lnTo>
                    <a:lnTo>
                      <a:pt x="1313561" y="2012315"/>
                    </a:lnTo>
                    <a:lnTo>
                      <a:pt x="1333881" y="2012315"/>
                    </a:lnTo>
                    <a:lnTo>
                      <a:pt x="1333881" y="2088515"/>
                    </a:lnTo>
                    <a:lnTo>
                      <a:pt x="1351280" y="2088515"/>
                    </a:lnTo>
                    <a:lnTo>
                      <a:pt x="1351280" y="2167001"/>
                    </a:lnTo>
                    <a:lnTo>
                      <a:pt x="1400556" y="2167001"/>
                    </a:lnTo>
                    <a:lnTo>
                      <a:pt x="1400556" y="2250694"/>
                    </a:lnTo>
                    <a:lnTo>
                      <a:pt x="1435354" y="2250694"/>
                    </a:lnTo>
                    <a:lnTo>
                      <a:pt x="1435354" y="2334387"/>
                    </a:lnTo>
                    <a:lnTo>
                      <a:pt x="1467231" y="2334387"/>
                    </a:lnTo>
                    <a:lnTo>
                      <a:pt x="1467231" y="2421128"/>
                    </a:lnTo>
                    <a:lnTo>
                      <a:pt x="1777492" y="2421128"/>
                    </a:lnTo>
                    <a:lnTo>
                      <a:pt x="1777492" y="2515108"/>
                    </a:lnTo>
                    <a:lnTo>
                      <a:pt x="1867408" y="2515108"/>
                    </a:lnTo>
                    <a:lnTo>
                      <a:pt x="1867408" y="2613406"/>
                    </a:lnTo>
                    <a:lnTo>
                      <a:pt x="1910969" y="2613406"/>
                    </a:lnTo>
                    <a:lnTo>
                      <a:pt x="1910969" y="2711704"/>
                    </a:lnTo>
                    <a:lnTo>
                      <a:pt x="1971802" y="2711704"/>
                    </a:lnTo>
                    <a:lnTo>
                      <a:pt x="1971802" y="2810002"/>
                    </a:lnTo>
                    <a:lnTo>
                      <a:pt x="2032762" y="2810002"/>
                    </a:lnTo>
                    <a:lnTo>
                      <a:pt x="2032762" y="2913761"/>
                    </a:lnTo>
                    <a:lnTo>
                      <a:pt x="2311146" y="2913761"/>
                    </a:lnTo>
                    <a:lnTo>
                      <a:pt x="2311146" y="3039745"/>
                    </a:lnTo>
                    <a:lnTo>
                      <a:pt x="2490851" y="3039745"/>
                    </a:lnTo>
                    <a:lnTo>
                      <a:pt x="2490851" y="3176270"/>
                    </a:lnTo>
                    <a:lnTo>
                      <a:pt x="2589530" y="3176270"/>
                    </a:lnTo>
                    <a:lnTo>
                      <a:pt x="2589530" y="3326384"/>
                    </a:lnTo>
                    <a:lnTo>
                      <a:pt x="3239008" y="3326384"/>
                    </a:lnTo>
                    <a:lnTo>
                      <a:pt x="3239008" y="3664077"/>
                    </a:lnTo>
                    <a:lnTo>
                      <a:pt x="3604387" y="3664077"/>
                    </a:lnTo>
                    <a:lnTo>
                      <a:pt x="3604387" y="4170807"/>
                    </a:lnTo>
                    <a:lnTo>
                      <a:pt x="3676904" y="4170807"/>
                    </a:lnTo>
                  </a:path>
                </a:pathLst>
              </a:custGeom>
              <a:ln w="19050">
                <a:solidFill>
                  <a:srgbClr val="006400"/>
                </a:solidFill>
              </a:ln>
            </p:spPr>
            <p:txBody>
              <a:bodyPr wrap="square" lIns="0" tIns="0" rIns="0" bIns="0" rtlCol="0">
                <a:noAutofit/>
              </a:bodyPr>
              <a:lstStyle/>
              <a:p>
                <a:endParaRPr sz="1834"/>
              </a:p>
            </p:txBody>
          </p:sp>
          <p:grpSp>
            <p:nvGrpSpPr>
              <p:cNvPr id="32" name="그룹 31">
                <a:extLst>
                  <a:ext uri="{FF2B5EF4-FFF2-40B4-BE49-F238E27FC236}">
                    <a16:creationId xmlns:a16="http://schemas.microsoft.com/office/drawing/2014/main" xmlns="" id="{A3202BB3-F0F4-40FB-A77E-50CEBD4E147C}"/>
                  </a:ext>
                </a:extLst>
              </p:cNvPr>
              <p:cNvGrpSpPr/>
              <p:nvPr/>
            </p:nvGrpSpPr>
            <p:grpSpPr>
              <a:xfrm>
                <a:off x="2838977" y="760721"/>
                <a:ext cx="6158863" cy="5897749"/>
                <a:chOff x="2838977" y="760721"/>
                <a:chExt cx="6158863" cy="5897749"/>
              </a:xfrm>
            </p:grpSpPr>
            <p:sp>
              <p:nvSpPr>
                <p:cNvPr id="7" name="object 7"/>
                <p:cNvSpPr/>
                <p:nvPr/>
              </p:nvSpPr>
              <p:spPr>
                <a:xfrm>
                  <a:off x="3480127" y="5717112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8" name="object 8"/>
                <p:cNvSpPr/>
                <p:nvPr/>
              </p:nvSpPr>
              <p:spPr>
                <a:xfrm>
                  <a:off x="3480127" y="4763981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9" name="object 9"/>
                <p:cNvSpPr/>
                <p:nvPr/>
              </p:nvSpPr>
              <p:spPr>
                <a:xfrm>
                  <a:off x="3480127" y="3810848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10" name="object 10"/>
                <p:cNvSpPr/>
                <p:nvPr/>
              </p:nvSpPr>
              <p:spPr>
                <a:xfrm>
                  <a:off x="3480127" y="2857585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11" name="object 11"/>
                <p:cNvSpPr/>
                <p:nvPr/>
              </p:nvSpPr>
              <p:spPr>
                <a:xfrm>
                  <a:off x="3480127" y="1904453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/>
                </a:p>
              </p:txBody>
            </p:sp>
            <p:sp>
              <p:nvSpPr>
                <p:cNvPr id="12" name="object 12"/>
                <p:cNvSpPr/>
                <p:nvPr/>
              </p:nvSpPr>
              <p:spPr>
                <a:xfrm>
                  <a:off x="3480127" y="951320"/>
                  <a:ext cx="93164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91439">
                      <a:moveTo>
                        <a:pt x="91439" y="0"/>
                      </a:moveTo>
                      <a:lnTo>
                        <a:pt x="0" y="0"/>
                      </a:lnTo>
                    </a:path>
                  </a:pathLst>
                </a:custGeom>
                <a:ln w="9525">
                  <a:solidFill>
                    <a:srgbClr val="000000"/>
                  </a:solidFill>
                </a:ln>
              </p:spPr>
              <p:txBody>
                <a:bodyPr wrap="square" lIns="0" tIns="0" rIns="0" bIns="0" rtlCol="0">
                  <a:noAutofit/>
                </a:bodyPr>
                <a:lstStyle/>
                <a:p>
                  <a:endParaRPr sz="1834" dirty="0"/>
                </a:p>
              </p:txBody>
            </p:sp>
            <p:grpSp>
              <p:nvGrpSpPr>
                <p:cNvPr id="31" name="그룹 30">
                  <a:extLst>
                    <a:ext uri="{FF2B5EF4-FFF2-40B4-BE49-F238E27FC236}">
                      <a16:creationId xmlns:a16="http://schemas.microsoft.com/office/drawing/2014/main" xmlns="" id="{FCB0BDCD-FE6B-421F-956E-CA7CB18A8CAD}"/>
                    </a:ext>
                  </a:extLst>
                </p:cNvPr>
                <p:cNvGrpSpPr/>
                <p:nvPr/>
              </p:nvGrpSpPr>
              <p:grpSpPr>
                <a:xfrm>
                  <a:off x="2838977" y="760721"/>
                  <a:ext cx="6158863" cy="5897749"/>
                  <a:chOff x="2838977" y="760721"/>
                  <a:chExt cx="6158863" cy="5897749"/>
                </a:xfrm>
              </p:grpSpPr>
              <p:sp>
                <p:nvSpPr>
                  <p:cNvPr id="14" name="object 14"/>
                  <p:cNvSpPr txBox="1"/>
                  <p:nvPr/>
                </p:nvSpPr>
                <p:spPr>
                  <a:xfrm>
                    <a:off x="3194419" y="4643124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2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6" name="object 16"/>
                  <p:cNvSpPr txBox="1"/>
                  <p:nvPr/>
                </p:nvSpPr>
                <p:spPr>
                  <a:xfrm>
                    <a:off x="3194419" y="2736730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0.6</a:t>
                    </a:r>
                    <a:endParaRPr sz="1223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8" name="object 18"/>
                  <p:cNvSpPr txBox="1"/>
                  <p:nvPr/>
                </p:nvSpPr>
                <p:spPr>
                  <a:xfrm>
                    <a:off x="3194419" y="830465"/>
                    <a:ext cx="197976" cy="241971"/>
                  </a:xfrm>
                  <a:prstGeom prst="rect">
                    <a:avLst/>
                  </a:prstGeom>
                </p:spPr>
                <p:txBody>
                  <a:bodyPr vert="vert270" wrap="square" lIns="0" tIns="0" rIns="0" bIns="0" rtlCol="0">
                    <a:noAutofit/>
                  </a:bodyPr>
                  <a:lstStyle/>
                  <a:p>
                    <a:pPr marL="12940"/>
                    <a:r>
                      <a:rPr sz="1223" dirty="0">
                        <a:latin typeface="Arial"/>
                        <a:cs typeface="Arial"/>
                      </a:rPr>
                      <a:t>1.0</a:t>
                    </a:r>
                  </a:p>
                </p:txBody>
              </p:sp>
              <p:grpSp>
                <p:nvGrpSpPr>
                  <p:cNvPr id="30" name="그룹 29">
                    <a:extLst>
                      <a:ext uri="{FF2B5EF4-FFF2-40B4-BE49-F238E27FC236}">
                        <a16:creationId xmlns:a16="http://schemas.microsoft.com/office/drawing/2014/main" xmlns="" id="{89784A2C-FE94-4667-9A2D-AF04096D2147}"/>
                      </a:ext>
                    </a:extLst>
                  </p:cNvPr>
                  <p:cNvGrpSpPr/>
                  <p:nvPr/>
                </p:nvGrpSpPr>
                <p:grpSpPr>
                  <a:xfrm>
                    <a:off x="2838977" y="760721"/>
                    <a:ext cx="6158863" cy="5897749"/>
                    <a:chOff x="2838977" y="760721"/>
                    <a:chExt cx="6158863" cy="5897749"/>
                  </a:xfrm>
                </p:grpSpPr>
                <p:sp>
                  <p:nvSpPr>
                    <p:cNvPr id="2" name="object 2"/>
                    <p:cNvSpPr txBox="1"/>
                    <p:nvPr/>
                  </p:nvSpPr>
                  <p:spPr>
                    <a:xfrm>
                      <a:off x="3718086" y="6087834"/>
                      <a:ext cx="112574" cy="197976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0</a:t>
                      </a:r>
                    </a:p>
                  </p:txBody>
                </p:sp>
                <p:sp>
                  <p:nvSpPr>
                    <p:cNvPr id="3" name="object 3"/>
                    <p:cNvSpPr txBox="1"/>
                    <p:nvPr/>
                  </p:nvSpPr>
                  <p:spPr>
                    <a:xfrm>
                      <a:off x="5152184" y="6087834"/>
                      <a:ext cx="198623" cy="197976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50</a:t>
                      </a:r>
                      <a:endParaRPr sz="1223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" name="object 4"/>
                    <p:cNvSpPr txBox="1"/>
                    <p:nvPr/>
                  </p:nvSpPr>
                  <p:spPr>
                    <a:xfrm>
                      <a:off x="6586283" y="6087834"/>
                      <a:ext cx="285319" cy="197976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100</a:t>
                      </a:r>
                    </a:p>
                  </p:txBody>
                </p:sp>
                <p:sp>
                  <p:nvSpPr>
                    <p:cNvPr id="5" name="object 5"/>
                    <p:cNvSpPr txBox="1"/>
                    <p:nvPr/>
                  </p:nvSpPr>
                  <p:spPr>
                    <a:xfrm>
                      <a:off x="8063598" y="6087834"/>
                      <a:ext cx="285319" cy="197976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150</a:t>
                      </a:r>
                    </a:p>
                  </p:txBody>
                </p:sp>
                <p:sp>
                  <p:nvSpPr>
                    <p:cNvPr id="15" name="object 15"/>
                    <p:cNvSpPr txBox="1"/>
                    <p:nvPr/>
                  </p:nvSpPr>
                  <p:spPr>
                    <a:xfrm>
                      <a:off x="3194419" y="3689992"/>
                      <a:ext cx="197976" cy="241971"/>
                    </a:xfrm>
                    <a:prstGeom prst="rect">
                      <a:avLst/>
                    </a:prstGeom>
                  </p:spPr>
                  <p:txBody>
                    <a:bodyPr vert="vert270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0.4</a:t>
                      </a:r>
                    </a:p>
                  </p:txBody>
                </p:sp>
                <p:sp>
                  <p:nvSpPr>
                    <p:cNvPr id="17" name="object 17"/>
                    <p:cNvSpPr txBox="1"/>
                    <p:nvPr/>
                  </p:nvSpPr>
                  <p:spPr>
                    <a:xfrm>
                      <a:off x="3194419" y="1783597"/>
                      <a:ext cx="197976" cy="241971"/>
                    </a:xfrm>
                    <a:prstGeom prst="rect">
                      <a:avLst/>
                    </a:prstGeom>
                  </p:spPr>
                  <p:txBody>
                    <a:bodyPr vert="vert270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0.8</a:t>
                      </a:r>
                      <a:endParaRPr sz="1223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9" name="object 19"/>
                    <p:cNvSpPr/>
                    <p:nvPr/>
                  </p:nvSpPr>
                  <p:spPr>
                    <a:xfrm>
                      <a:off x="3573291" y="760721"/>
                      <a:ext cx="5424549" cy="5146994"/>
                    </a:xfrm>
                    <a:custGeom>
                      <a:avLst/>
                      <a:gdLst/>
                      <a:ahLst/>
                      <a:cxnLst/>
                      <a:rect l="l" t="t" r="r" b="b"/>
                      <a:pathLst>
                        <a:path w="5324094" h="5051679">
                          <a:moveTo>
                            <a:pt x="0" y="5051679"/>
                          </a:moveTo>
                          <a:lnTo>
                            <a:pt x="5324094" y="5051679"/>
                          </a:lnTo>
                          <a:lnTo>
                            <a:pt x="5324094" y="0"/>
                          </a:lnTo>
                          <a:lnTo>
                            <a:pt x="0" y="0"/>
                          </a:lnTo>
                          <a:lnTo>
                            <a:pt x="0" y="5051679"/>
                          </a:lnTo>
                        </a:path>
                      </a:pathLst>
                    </a:custGeom>
                    <a:ln w="9525">
                      <a:solidFill>
                        <a:schemeClr val="tx1"/>
                      </a:solidFill>
                    </a:ln>
                  </p:spPr>
                  <p:txBody>
                    <a:bodyPr wrap="square" lIns="0" tIns="0" rIns="0" bIns="0" rtlCol="0">
                      <a:noAutofit/>
                    </a:bodyPr>
                    <a:lstStyle/>
                    <a:p>
                      <a:endParaRPr sz="1834"/>
                    </a:p>
                  </p:txBody>
                </p:sp>
                <p:sp>
                  <p:nvSpPr>
                    <p:cNvPr id="20" name="object 20"/>
                    <p:cNvSpPr txBox="1"/>
                    <p:nvPr/>
                  </p:nvSpPr>
                  <p:spPr>
                    <a:xfrm>
                      <a:off x="5793859" y="6460494"/>
                      <a:ext cx="984058" cy="197976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sz="1223" dirty="0">
                          <a:latin typeface="Arial"/>
                          <a:cs typeface="Arial"/>
                        </a:rPr>
                        <a:t>Time(months)</a:t>
                      </a:r>
                    </a:p>
                  </p:txBody>
                </p:sp>
                <p:sp>
                  <p:nvSpPr>
                    <p:cNvPr id="21" name="object 21"/>
                    <p:cNvSpPr txBox="1"/>
                    <p:nvPr/>
                  </p:nvSpPr>
                  <p:spPr>
                    <a:xfrm>
                      <a:off x="2838977" y="2329354"/>
                      <a:ext cx="220731" cy="2216014"/>
                    </a:xfrm>
                    <a:prstGeom prst="rect">
                      <a:avLst/>
                    </a:prstGeom>
                  </p:spPr>
                  <p:txBody>
                    <a:bodyPr vert="vert270" wrap="square" lIns="0" tIns="0" rIns="0" bIns="0" rtlCol="0">
                      <a:noAutofit/>
                    </a:bodyPr>
                    <a:lstStyle/>
                    <a:p>
                      <a:pPr marL="12940"/>
                      <a:r>
                        <a:rPr lang="en-US" altLang="ko-KR" sz="1200" dirty="0">
                          <a:latin typeface="Arial"/>
                          <a:cs typeface="Arial"/>
                        </a:rPr>
                        <a:t>Overall su</a:t>
                      </a:r>
                      <a:r>
                        <a:rPr lang="en-US" altLang="ko-KR" sz="1200" spc="36" dirty="0">
                          <a:latin typeface="Arial"/>
                          <a:cs typeface="Arial"/>
                        </a:rPr>
                        <a:t>r</a:t>
                      </a:r>
                      <a:r>
                        <a:rPr lang="en-US" altLang="ko-KR" sz="1200" dirty="0">
                          <a:latin typeface="Arial"/>
                          <a:cs typeface="Arial"/>
                        </a:rPr>
                        <a:t>vi</a:t>
                      </a:r>
                      <a:r>
                        <a:rPr lang="en-US" altLang="ko-KR" sz="1200" spc="-31" dirty="0">
                          <a:latin typeface="Arial"/>
                          <a:cs typeface="Arial"/>
                        </a:rPr>
                        <a:t>v</a:t>
                      </a:r>
                      <a:r>
                        <a:rPr lang="en-US" altLang="ko-KR" sz="1200" dirty="0">
                          <a:latin typeface="Arial"/>
                          <a:cs typeface="Arial"/>
                        </a:rPr>
                        <a:t>al (Probability)</a:t>
                      </a:r>
                    </a:p>
                  </p:txBody>
                </p:sp>
                <p:sp>
                  <p:nvSpPr>
                    <p:cNvPr id="26" name="object 26"/>
                    <p:cNvSpPr/>
                    <p:nvPr/>
                  </p:nvSpPr>
                  <p:spPr>
                    <a:xfrm>
                      <a:off x="7528545" y="947051"/>
                      <a:ext cx="279496" cy="0"/>
                    </a:xfrm>
                    <a:custGeom>
                      <a:avLst/>
                      <a:gdLst/>
                      <a:ahLst/>
                      <a:cxnLst/>
                      <a:rect l="l" t="t" r="r" b="b"/>
                      <a:pathLst>
                        <a:path w="274320">
                          <a:moveTo>
                            <a:pt x="0" y="0"/>
                          </a:moveTo>
                          <a:lnTo>
                            <a:pt x="274320" y="0"/>
                          </a:lnTo>
                        </a:path>
                      </a:pathLst>
                    </a:custGeom>
                    <a:ln w="19050">
                      <a:solidFill>
                        <a:srgbClr val="A020F0"/>
                      </a:solidFill>
                    </a:ln>
                  </p:spPr>
                  <p:txBody>
                    <a:bodyPr wrap="square" lIns="0" tIns="0" rIns="0" bIns="0" rtlCol="0">
                      <a:noAutofit/>
                    </a:bodyPr>
                    <a:lstStyle/>
                    <a:p>
                      <a:endParaRPr sz="1834"/>
                    </a:p>
                  </p:txBody>
                </p:sp>
                <p:sp>
                  <p:nvSpPr>
                    <p:cNvPr id="27" name="object 27"/>
                    <p:cNvSpPr/>
                    <p:nvPr/>
                  </p:nvSpPr>
                  <p:spPr>
                    <a:xfrm>
                      <a:off x="7528545" y="1133381"/>
                      <a:ext cx="279496" cy="0"/>
                    </a:xfrm>
                    <a:custGeom>
                      <a:avLst/>
                      <a:gdLst/>
                      <a:ahLst/>
                      <a:cxnLst/>
                      <a:rect l="l" t="t" r="r" b="b"/>
                      <a:pathLst>
                        <a:path w="274320">
                          <a:moveTo>
                            <a:pt x="0" y="0"/>
                          </a:moveTo>
                          <a:lnTo>
                            <a:pt x="274320" y="0"/>
                          </a:lnTo>
                        </a:path>
                      </a:pathLst>
                    </a:custGeom>
                    <a:ln w="19050">
                      <a:solidFill>
                        <a:srgbClr val="006400"/>
                      </a:solidFill>
                    </a:ln>
                  </p:spPr>
                  <p:txBody>
                    <a:bodyPr wrap="square" lIns="0" tIns="0" rIns="0" bIns="0" rtlCol="0">
                      <a:noAutofit/>
                    </a:bodyPr>
                    <a:lstStyle/>
                    <a:p>
                      <a:endParaRPr sz="1834"/>
                    </a:p>
                  </p:txBody>
                </p:sp>
                <p:sp>
                  <p:nvSpPr>
                    <p:cNvPr id="28" name="object 28"/>
                    <p:cNvSpPr txBox="1"/>
                    <p:nvPr/>
                  </p:nvSpPr>
                  <p:spPr>
                    <a:xfrm>
                      <a:off x="7934849" y="847545"/>
                      <a:ext cx="1044228" cy="384307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940" marR="12940"/>
                      <a:r>
                        <a:rPr sz="1223" dirty="0">
                          <a:latin typeface="Arial"/>
                          <a:cs typeface="Arial"/>
                        </a:rPr>
                        <a:t>LC without IPF LC with IPF</a:t>
                      </a:r>
                    </a:p>
                  </p:txBody>
                </p:sp>
                <p:sp>
                  <p:nvSpPr>
                    <p:cNvPr id="29" name="object 31">
                      <a:extLst>
                        <a:ext uri="{FF2B5EF4-FFF2-40B4-BE49-F238E27FC236}">
                          <a16:creationId xmlns:a16="http://schemas.microsoft.com/office/drawing/2014/main" xmlns="" id="{BFBC593B-4E07-4409-B935-8B264160C1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25362" y="3437361"/>
                      <a:ext cx="1220970" cy="264845"/>
                    </a:xfrm>
                    <a:prstGeom prst="rect">
                      <a:avLst/>
                    </a:prstGeom>
                  </p:spPr>
                  <p:txBody>
                    <a:bodyPr vert="horz" wrap="square" lIns="0" tIns="0" rIns="0" bIns="0" rtlCol="0">
                      <a:noAutofit/>
                    </a:bodyPr>
                    <a:lstStyle/>
                    <a:p>
                      <a:pPr marL="12701"/>
                      <a:r>
                        <a:rPr lang="en-US" sz="12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200" dirty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altLang="ko-KR" sz="1200" dirty="0">
                          <a:latin typeface="Arial"/>
                          <a:cs typeface="Arial"/>
                        </a:rPr>
                        <a:t>&lt;</a:t>
                      </a:r>
                      <a:r>
                        <a:rPr sz="1200" dirty="0">
                          <a:latin typeface="Arial"/>
                          <a:cs typeface="Arial"/>
                        </a:rPr>
                        <a:t> 0.00</a:t>
                      </a:r>
                      <a:r>
                        <a:rPr lang="en-US" altLang="ko-KR" sz="1200" dirty="0">
                          <a:latin typeface="Arial"/>
                          <a:cs typeface="Arial"/>
                        </a:rPr>
                        <a:t>1</a:t>
                      </a:r>
                      <a:endParaRPr sz="1200" dirty="0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</p:grp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DFE10AD7-2AB8-43D5-8E37-AA301DEA8806}"/>
              </a:ext>
            </a:extLst>
          </p:cNvPr>
          <p:cNvSpPr txBox="1"/>
          <p:nvPr/>
        </p:nvSpPr>
        <p:spPr>
          <a:xfrm>
            <a:off x="171558" y="256338"/>
            <a:ext cx="25233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2B Fig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0</Words>
  <Application>Microsoft Office PowerPoint</Application>
  <PresentationFormat>Custom</PresentationFormat>
  <Paragraphs>3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송명진</dc:creator>
  <cp:lastModifiedBy>Manikandan R</cp:lastModifiedBy>
  <cp:revision>2</cp:revision>
  <dcterms:created xsi:type="dcterms:W3CDTF">2020-05-19T00:58:35Z</dcterms:created>
  <dcterms:modified xsi:type="dcterms:W3CDTF">2020-06-21T05:46:36Z</dcterms:modified>
</cp:coreProperties>
</file>